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15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015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2517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071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478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140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0041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9900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200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825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377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247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A80D0-5559-4FE9-98E4-F78B7087D7BE}" type="datetimeFigureOut">
              <a:rPr kumimoji="1" lang="ja-JP" altLang="en-US" smtClean="0"/>
              <a:t>2012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AE785-1174-4723-8383-EE7A17FA1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559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4352639"/>
              </p:ext>
            </p:extLst>
          </p:nvPr>
        </p:nvGraphicFramePr>
        <p:xfrm>
          <a:off x="2319338" y="260648"/>
          <a:ext cx="4505325" cy="4905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SPW 12.0 Graph" r:id="rId3" imgW="4501440" imgH="4902840" progId="SigmaPlotGraphicObject.11">
                  <p:embed/>
                </p:oleObj>
              </mc:Choice>
              <mc:Fallback>
                <p:oleObj name="SPW 12.0 Graph" r:id="rId3" imgW="4501440" imgH="4902840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19338" y="260648"/>
                        <a:ext cx="4505325" cy="4905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1691680" y="5157192"/>
            <a:ext cx="61206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Fluid responsiveness was defined by an increase in </a:t>
            </a:r>
            <a:r>
              <a:rPr lang="en-US" altLang="ja-JP" dirty="0" smtClean="0"/>
              <a:t>stroke volume index (SVI) &gt;15</a:t>
            </a:r>
            <a:r>
              <a:rPr lang="en-US" altLang="ja-JP" dirty="0"/>
              <a:t>% </a:t>
            </a:r>
            <a:r>
              <a:rPr lang="en-US" altLang="ja-JP" dirty="0" smtClean="0"/>
              <a:t>after volume loading compare to the pre-loading SVI.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77920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6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Office ​​テーマ</vt:lpstr>
      <vt:lpstr>SigmaPlot 12.0 Graph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shihara</dc:creator>
  <cp:lastModifiedBy>ishihara</cp:lastModifiedBy>
  <cp:revision>2</cp:revision>
  <dcterms:created xsi:type="dcterms:W3CDTF">2012-12-03T04:54:46Z</dcterms:created>
  <dcterms:modified xsi:type="dcterms:W3CDTF">2012-12-03T05:05:12Z</dcterms:modified>
</cp:coreProperties>
</file>